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6187"/>
    <p:restoredTop sz="95884"/>
  </p:normalViewPr>
  <p:slideViewPr>
    <p:cSldViewPr snapToGrid="0">
      <p:cViewPr varScale="1">
        <p:scale>
          <a:sx n="36" d="100"/>
          <a:sy n="36" d="100"/>
        </p:scale>
        <p:origin x="240" y="18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37395D-A2B1-AE08-CC97-533A23045FD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89FFA7F-4FD1-1634-2B6F-AC0299FD4C5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B097690-3383-EE77-B6C0-A3674A230559}"/>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C7E20825-10E1-B711-0040-7B6E35E861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CE9C3D-D97C-D604-E5FF-6C64C1735F49}"/>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3854314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A6E9A2-8EC2-64AA-4214-40D847FA4EF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D717E09-3144-27CB-E92A-A6FAEECBD54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4338E8-2069-D5D1-6619-91E9EBB740A8}"/>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D5B8857D-7461-2884-987F-33F7EB37F8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08FCAB-542E-33B7-6F60-D0247E0362D2}"/>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18973624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9B66514-3ABE-F251-56C3-141B687640A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ADB4B0-B3F7-A51F-0A2E-C24DBA9E35B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62505D-D4C8-7AD1-B5F0-63514D51A0A8}"/>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33DB1F43-0F20-8DF3-4A1E-5AA61566FD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8B8598-A0FF-B45F-92A0-B14A532F2A9E}"/>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36011075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3B0A21-789F-FD95-C2EF-BBA9DC99B6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5677C5F-5320-33EC-E097-1868B613A52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79695FF-BAA3-6583-0540-3A979F97C0B8}"/>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DA226209-C7F3-9F42-0855-E390B91013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8375E7-ADA2-7A30-1546-8D803EA76F8A}"/>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28398156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48D431-0256-0498-55A9-D0D17F7C598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D2E4F6A-A3C0-8E6D-C410-7CB01860941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CF7DD4C-B013-7CA1-780E-39D79DB2AEE7}"/>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009D9EA1-0E65-950C-817E-E7EB7B1D54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81EC18-5A36-1465-3C59-7BEDFCCD2B54}"/>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27123175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847755-51E9-0E72-334D-08D154B815C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1915FA3-E0A1-FF1B-731E-8A754743A80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11435D9-E1D9-813F-2358-EBA0B6F049B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FC36AE4-B68B-211D-5617-7E64ABAFA86A}"/>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6" name="Footer Placeholder 5">
            <a:extLst>
              <a:ext uri="{FF2B5EF4-FFF2-40B4-BE49-F238E27FC236}">
                <a16:creationId xmlns:a16="http://schemas.microsoft.com/office/drawing/2014/main" id="{25235E24-3D23-A490-E2B3-29A87C35E6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397D60-66DA-EEA4-BE56-A9887F4B5D23}"/>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37491221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B5E829-CA3F-C78C-077B-58093D999BC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630BF6E-05C6-958D-A44C-0A6EEF950F4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3397A3A-965D-A50C-474A-8C636D61889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2975363-CE28-43AB-B4A3-7E7B13CD61D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9BAADC9-5318-E146-B2E2-41A725D64F8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61B1F28-AB58-5171-263A-2723B598D3D6}"/>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8" name="Footer Placeholder 7">
            <a:extLst>
              <a:ext uri="{FF2B5EF4-FFF2-40B4-BE49-F238E27FC236}">
                <a16:creationId xmlns:a16="http://schemas.microsoft.com/office/drawing/2014/main" id="{147AA1C7-6405-0283-CB9D-A29B2AEB46B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4214FDB-EF5B-8CD3-8103-76C5CF4BC149}"/>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2591982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2C497A-3229-751E-745E-CF27C478549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849578D-57F2-24A4-A125-EAA4FF0AE2CE}"/>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4" name="Footer Placeholder 3">
            <a:extLst>
              <a:ext uri="{FF2B5EF4-FFF2-40B4-BE49-F238E27FC236}">
                <a16:creationId xmlns:a16="http://schemas.microsoft.com/office/drawing/2014/main" id="{F35B8B8A-A63E-460D-756C-694BCD532FD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4320437-FE67-9338-16CB-87681689256B}"/>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2233883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63D3FDD-E836-DA93-11B2-463FB9188E8E}"/>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3" name="Footer Placeholder 2">
            <a:extLst>
              <a:ext uri="{FF2B5EF4-FFF2-40B4-BE49-F238E27FC236}">
                <a16:creationId xmlns:a16="http://schemas.microsoft.com/office/drawing/2014/main" id="{918BB8A7-0032-C6D5-641D-2CE13C6D353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0214CE9-8F5E-9AA5-7142-429EE33F115E}"/>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1133331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1A98FC-F8ED-4D1F-C371-2C33279476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B00BB1B-BA7E-E5F2-91C8-1043BDB48A7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9982E3D-EF2C-7DD8-444F-94CD69309A7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DC7D97-69B9-3A74-D541-A3A478055FB8}"/>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6" name="Footer Placeholder 5">
            <a:extLst>
              <a:ext uri="{FF2B5EF4-FFF2-40B4-BE49-F238E27FC236}">
                <a16:creationId xmlns:a16="http://schemas.microsoft.com/office/drawing/2014/main" id="{196DA07F-7B17-5EB5-3797-A9417675F3A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1C33E1-577F-E2FA-8849-29AFC83F4F04}"/>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1673611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107E57-83C9-F00B-7BE7-98ABDCC10F0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E3A92C7-36CD-946A-C32B-53E512F7305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35E8988-64F8-E62D-A490-217F62E939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22B7995-64A8-5BAC-A650-3123B237D6E8}"/>
              </a:ext>
            </a:extLst>
          </p:cNvPr>
          <p:cNvSpPr>
            <a:spLocks noGrp="1"/>
          </p:cNvSpPr>
          <p:nvPr>
            <p:ph type="dt" sz="half" idx="10"/>
          </p:nvPr>
        </p:nvSpPr>
        <p:spPr/>
        <p:txBody>
          <a:bodyPr/>
          <a:lstStyle/>
          <a:p>
            <a:fld id="{327687D8-CE2D-B64F-98D4-B19C32306FE2}" type="datetimeFigureOut">
              <a:rPr lang="en-US" smtClean="0"/>
              <a:t>1/18/23</a:t>
            </a:fld>
            <a:endParaRPr lang="en-US"/>
          </a:p>
        </p:txBody>
      </p:sp>
      <p:sp>
        <p:nvSpPr>
          <p:cNvPr id="6" name="Footer Placeholder 5">
            <a:extLst>
              <a:ext uri="{FF2B5EF4-FFF2-40B4-BE49-F238E27FC236}">
                <a16:creationId xmlns:a16="http://schemas.microsoft.com/office/drawing/2014/main" id="{B8D63A0F-3D89-7C73-2F7E-5E89383CD2F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B9E0A0-40C8-3E83-B29F-0C4DDA20AB9D}"/>
              </a:ext>
            </a:extLst>
          </p:cNvPr>
          <p:cNvSpPr>
            <a:spLocks noGrp="1"/>
          </p:cNvSpPr>
          <p:nvPr>
            <p:ph type="sldNum" sz="quarter" idx="12"/>
          </p:nvPr>
        </p:nvSpPr>
        <p:spPr/>
        <p:txBody>
          <a:bodyPr/>
          <a:lstStyle/>
          <a:p>
            <a:fld id="{B29352A4-8646-A54E-9FEE-432E95BE91B2}" type="slidenum">
              <a:rPr lang="en-US" smtClean="0"/>
              <a:t>‹#›</a:t>
            </a:fld>
            <a:endParaRPr lang="en-US"/>
          </a:p>
        </p:txBody>
      </p:sp>
    </p:spTree>
    <p:extLst>
      <p:ext uri="{BB962C8B-B14F-4D97-AF65-F5344CB8AC3E}">
        <p14:creationId xmlns:p14="http://schemas.microsoft.com/office/powerpoint/2010/main" val="25089573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7FE85F5-5A0C-EB5F-EC3E-95B1C1A25E7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86A5ACB-AE67-EFA8-21CC-317B19B7F64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1D7A4A-DDF0-F3D5-A795-0A85F7BA5D1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7687D8-CE2D-B64F-98D4-B19C32306FE2}" type="datetimeFigureOut">
              <a:rPr lang="en-US" smtClean="0"/>
              <a:t>1/18/23</a:t>
            </a:fld>
            <a:endParaRPr lang="en-US"/>
          </a:p>
        </p:txBody>
      </p:sp>
      <p:sp>
        <p:nvSpPr>
          <p:cNvPr id="5" name="Footer Placeholder 4">
            <a:extLst>
              <a:ext uri="{FF2B5EF4-FFF2-40B4-BE49-F238E27FC236}">
                <a16:creationId xmlns:a16="http://schemas.microsoft.com/office/drawing/2014/main" id="{EC0427C3-5226-D68E-EAB2-20DE8DEC3B0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409C92B-949F-2A7B-B045-A246D134FC3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9352A4-8646-A54E-9FEE-432E95BE91B2}" type="slidenum">
              <a:rPr lang="en-US" smtClean="0"/>
              <a:t>‹#›</a:t>
            </a:fld>
            <a:endParaRPr lang="en-US"/>
          </a:p>
        </p:txBody>
      </p:sp>
    </p:spTree>
    <p:extLst>
      <p:ext uri="{BB962C8B-B14F-4D97-AF65-F5344CB8AC3E}">
        <p14:creationId xmlns:p14="http://schemas.microsoft.com/office/powerpoint/2010/main" val="25881975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png"/><Relationship Id="rId7" Type="http://schemas.openxmlformats.org/officeDocument/2006/relationships/image" Target="../media/image6.emf"/><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155609A-EF19-234A-8F88-90A916B78F2A}"/>
              </a:ext>
            </a:extLst>
          </p:cNvPr>
          <p:cNvSpPr txBox="1"/>
          <p:nvPr/>
        </p:nvSpPr>
        <p:spPr>
          <a:xfrm>
            <a:off x="0" y="0"/>
            <a:ext cx="402546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upplementary Figure 2</a:t>
            </a:r>
          </a:p>
        </p:txBody>
      </p:sp>
      <p:pic>
        <p:nvPicPr>
          <p:cNvPr id="2" name="Picture 1">
            <a:extLst>
              <a:ext uri="{FF2B5EF4-FFF2-40B4-BE49-F238E27FC236}">
                <a16:creationId xmlns:a16="http://schemas.microsoft.com/office/drawing/2014/main" id="{2B4C4AD3-0F45-1AE4-37C3-45D181FC2762}"/>
              </a:ext>
            </a:extLst>
          </p:cNvPr>
          <p:cNvPicPr>
            <a:picLocks noChangeAspect="1"/>
          </p:cNvPicPr>
          <p:nvPr/>
        </p:nvPicPr>
        <p:blipFill>
          <a:blip r:embed="rId2"/>
          <a:stretch>
            <a:fillRect/>
          </a:stretch>
        </p:blipFill>
        <p:spPr>
          <a:xfrm>
            <a:off x="103187" y="700442"/>
            <a:ext cx="7709717" cy="4643452"/>
          </a:xfrm>
          <a:prstGeom prst="rect">
            <a:avLst/>
          </a:prstGeom>
        </p:spPr>
      </p:pic>
      <p:sp>
        <p:nvSpPr>
          <p:cNvPr id="6" name="TextBox 5">
            <a:extLst>
              <a:ext uri="{FF2B5EF4-FFF2-40B4-BE49-F238E27FC236}">
                <a16:creationId xmlns:a16="http://schemas.microsoft.com/office/drawing/2014/main" id="{62C9EBEA-7AED-BA8B-7FCD-E88B2E007F1E}"/>
              </a:ext>
            </a:extLst>
          </p:cNvPr>
          <p:cNvSpPr txBox="1"/>
          <p:nvPr/>
        </p:nvSpPr>
        <p:spPr>
          <a:xfrm>
            <a:off x="8406196" y="12529"/>
            <a:ext cx="679545" cy="276999"/>
          </a:xfrm>
          <a:prstGeom prst="rect">
            <a:avLst/>
          </a:prstGeom>
          <a:noFill/>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BT-142</a:t>
            </a:r>
          </a:p>
        </p:txBody>
      </p:sp>
      <p:sp>
        <p:nvSpPr>
          <p:cNvPr id="7" name="TextBox 6">
            <a:extLst>
              <a:ext uri="{FF2B5EF4-FFF2-40B4-BE49-F238E27FC236}">
                <a16:creationId xmlns:a16="http://schemas.microsoft.com/office/drawing/2014/main" id="{1620973D-E67D-B859-50C3-83F6042E5E4E}"/>
              </a:ext>
            </a:extLst>
          </p:cNvPr>
          <p:cNvSpPr txBox="1"/>
          <p:nvPr/>
        </p:nvSpPr>
        <p:spPr>
          <a:xfrm>
            <a:off x="8956026" y="12529"/>
            <a:ext cx="439544" cy="276999"/>
          </a:xfrm>
          <a:prstGeom prst="rect">
            <a:avLst/>
          </a:prstGeom>
          <a:noFill/>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252</a:t>
            </a:r>
          </a:p>
        </p:txBody>
      </p:sp>
      <p:sp>
        <p:nvSpPr>
          <p:cNvPr id="8" name="TextBox 7">
            <a:extLst>
              <a:ext uri="{FF2B5EF4-FFF2-40B4-BE49-F238E27FC236}">
                <a16:creationId xmlns:a16="http://schemas.microsoft.com/office/drawing/2014/main" id="{EB6C4C7B-BFD2-C47A-8FF3-CE8B1F65B0E0}"/>
              </a:ext>
            </a:extLst>
          </p:cNvPr>
          <p:cNvSpPr txBox="1"/>
          <p:nvPr/>
        </p:nvSpPr>
        <p:spPr>
          <a:xfrm>
            <a:off x="9461043" y="12529"/>
            <a:ext cx="439544" cy="276999"/>
          </a:xfrm>
          <a:prstGeom prst="rect">
            <a:avLst/>
          </a:prstGeom>
          <a:noFill/>
        </p:spPr>
        <p:txBody>
          <a:bodyPr wrap="none" rtlCol="0">
            <a:spAutoFit/>
          </a:bodyPr>
          <a:lstStyle/>
          <a:p>
            <a:r>
              <a:rPr lang="en-US" sz="1200" dirty="0">
                <a:solidFill>
                  <a:srgbClr val="0070C0"/>
                </a:solidFill>
                <a:latin typeface="Arial" panose="020B0604020202020204" pitchFamily="34" charset="0"/>
                <a:cs typeface="Arial" panose="020B0604020202020204" pitchFamily="34" charset="0"/>
              </a:rPr>
              <a:t>357</a:t>
            </a:r>
          </a:p>
        </p:txBody>
      </p:sp>
      <p:sp>
        <p:nvSpPr>
          <p:cNvPr id="9" name="TextBox 8">
            <a:extLst>
              <a:ext uri="{FF2B5EF4-FFF2-40B4-BE49-F238E27FC236}">
                <a16:creationId xmlns:a16="http://schemas.microsoft.com/office/drawing/2014/main" id="{F9FD3047-6F9B-9A42-274E-4CE199FD9F57}"/>
              </a:ext>
            </a:extLst>
          </p:cNvPr>
          <p:cNvSpPr txBox="1"/>
          <p:nvPr/>
        </p:nvSpPr>
        <p:spPr>
          <a:xfrm>
            <a:off x="9966056" y="12529"/>
            <a:ext cx="439544" cy="276999"/>
          </a:xfrm>
          <a:prstGeom prst="rect">
            <a:avLst/>
          </a:prstGeom>
          <a:noFill/>
        </p:spPr>
        <p:txBody>
          <a:bodyPr wrap="none" rtlCol="0">
            <a:spAutoFit/>
          </a:bodyPr>
          <a:lstStyle/>
          <a:p>
            <a:r>
              <a:rPr lang="en-US" sz="1200" dirty="0">
                <a:solidFill>
                  <a:srgbClr val="0070C0"/>
                </a:solidFill>
                <a:latin typeface="Arial" panose="020B0604020202020204" pitchFamily="34" charset="0"/>
                <a:cs typeface="Arial" panose="020B0604020202020204" pitchFamily="34" charset="0"/>
              </a:rPr>
              <a:t>385</a:t>
            </a:r>
          </a:p>
        </p:txBody>
      </p:sp>
      <p:sp>
        <p:nvSpPr>
          <p:cNvPr id="10" name="TextBox 9">
            <a:extLst>
              <a:ext uri="{FF2B5EF4-FFF2-40B4-BE49-F238E27FC236}">
                <a16:creationId xmlns:a16="http://schemas.microsoft.com/office/drawing/2014/main" id="{E280C33E-14BA-E4F0-49D0-3E59BCCBFB0E}"/>
              </a:ext>
            </a:extLst>
          </p:cNvPr>
          <p:cNvSpPr txBox="1"/>
          <p:nvPr/>
        </p:nvSpPr>
        <p:spPr>
          <a:xfrm>
            <a:off x="10435974" y="12529"/>
            <a:ext cx="439544" cy="276999"/>
          </a:xfrm>
          <a:prstGeom prst="rect">
            <a:avLst/>
          </a:prstGeom>
          <a:noFill/>
        </p:spPr>
        <p:txBody>
          <a:bodyPr wrap="none" rtlCol="0">
            <a:spAutoFit/>
          </a:bodyPr>
          <a:lstStyle/>
          <a:p>
            <a:r>
              <a:rPr lang="en-US" sz="1200" dirty="0">
                <a:solidFill>
                  <a:srgbClr val="0070C0"/>
                </a:solidFill>
                <a:latin typeface="Arial" panose="020B0604020202020204" pitchFamily="34" charset="0"/>
                <a:cs typeface="Arial" panose="020B0604020202020204" pitchFamily="34" charset="0"/>
              </a:rPr>
              <a:t>412</a:t>
            </a:r>
          </a:p>
        </p:txBody>
      </p:sp>
      <p:pic>
        <p:nvPicPr>
          <p:cNvPr id="11" name="Picture 10">
            <a:extLst>
              <a:ext uri="{FF2B5EF4-FFF2-40B4-BE49-F238E27FC236}">
                <a16:creationId xmlns:a16="http://schemas.microsoft.com/office/drawing/2014/main" id="{728BA719-69D6-ED0E-3A39-063BC82507B0}"/>
              </a:ext>
            </a:extLst>
          </p:cNvPr>
          <p:cNvPicPr>
            <a:picLocks noChangeAspect="1"/>
          </p:cNvPicPr>
          <p:nvPr/>
        </p:nvPicPr>
        <p:blipFill>
          <a:blip r:embed="rId3"/>
          <a:stretch>
            <a:fillRect/>
          </a:stretch>
        </p:blipFill>
        <p:spPr>
          <a:xfrm>
            <a:off x="8490337" y="282779"/>
            <a:ext cx="2372744" cy="4226170"/>
          </a:xfrm>
          <a:prstGeom prst="rect">
            <a:avLst/>
          </a:prstGeom>
        </p:spPr>
      </p:pic>
      <p:sp>
        <p:nvSpPr>
          <p:cNvPr id="12" name="TextBox 11">
            <a:extLst>
              <a:ext uri="{FF2B5EF4-FFF2-40B4-BE49-F238E27FC236}">
                <a16:creationId xmlns:a16="http://schemas.microsoft.com/office/drawing/2014/main" id="{DA79F6B6-1E0A-0ABC-0F27-B0249FD613FB}"/>
              </a:ext>
            </a:extLst>
          </p:cNvPr>
          <p:cNvSpPr txBox="1"/>
          <p:nvPr/>
        </p:nvSpPr>
        <p:spPr>
          <a:xfrm>
            <a:off x="7823948" y="2777109"/>
            <a:ext cx="48282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LBH</a:t>
            </a:r>
          </a:p>
        </p:txBody>
      </p:sp>
      <p:cxnSp>
        <p:nvCxnSpPr>
          <p:cNvPr id="14" name="Straight Connector 13">
            <a:extLst>
              <a:ext uri="{FF2B5EF4-FFF2-40B4-BE49-F238E27FC236}">
                <a16:creationId xmlns:a16="http://schemas.microsoft.com/office/drawing/2014/main" id="{A8F54564-D7D7-09FB-A90A-41593D73F0EA}"/>
              </a:ext>
            </a:extLst>
          </p:cNvPr>
          <p:cNvCxnSpPr>
            <a:cxnSpLocks/>
          </p:cNvCxnSpPr>
          <p:nvPr/>
        </p:nvCxnSpPr>
        <p:spPr>
          <a:xfrm>
            <a:off x="8247888" y="2920291"/>
            <a:ext cx="246686" cy="0"/>
          </a:xfrm>
          <a:prstGeom prst="line">
            <a:avLst/>
          </a:prstGeom>
          <a:ln w="53975">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2DA542F6-62E0-3DD3-3084-FBB0B4F29075}"/>
              </a:ext>
            </a:extLst>
          </p:cNvPr>
          <p:cNvSpPr txBox="1"/>
          <p:nvPr/>
        </p:nvSpPr>
        <p:spPr>
          <a:xfrm>
            <a:off x="7702028" y="2057380"/>
            <a:ext cx="8089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Triptolide</a:t>
            </a:r>
          </a:p>
        </p:txBody>
      </p:sp>
      <p:cxnSp>
        <p:nvCxnSpPr>
          <p:cNvPr id="17" name="Straight Connector 16">
            <a:extLst>
              <a:ext uri="{FF2B5EF4-FFF2-40B4-BE49-F238E27FC236}">
                <a16:creationId xmlns:a16="http://schemas.microsoft.com/office/drawing/2014/main" id="{FBFF7F85-D268-EC33-2DE3-C23467E615A3}"/>
              </a:ext>
            </a:extLst>
          </p:cNvPr>
          <p:cNvCxnSpPr>
            <a:cxnSpLocks/>
            <a:endCxn id="16" idx="3"/>
          </p:cNvCxnSpPr>
          <p:nvPr/>
        </p:nvCxnSpPr>
        <p:spPr>
          <a:xfrm flipV="1">
            <a:off x="8400288" y="2195880"/>
            <a:ext cx="110679" cy="4682"/>
          </a:xfrm>
          <a:prstGeom prst="line">
            <a:avLst/>
          </a:prstGeom>
          <a:ln w="5397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1D33B5D3-6029-57AE-3AEC-FECE003D0D4B}"/>
              </a:ext>
            </a:extLst>
          </p:cNvPr>
          <p:cNvSpPr txBox="1"/>
          <p:nvPr/>
        </p:nvSpPr>
        <p:spPr>
          <a:xfrm>
            <a:off x="7686785" y="3912137"/>
            <a:ext cx="71365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S 275</a:t>
            </a:r>
          </a:p>
        </p:txBody>
      </p:sp>
      <p:cxnSp>
        <p:nvCxnSpPr>
          <p:cNvPr id="20" name="Straight Connector 19">
            <a:extLst>
              <a:ext uri="{FF2B5EF4-FFF2-40B4-BE49-F238E27FC236}">
                <a16:creationId xmlns:a16="http://schemas.microsoft.com/office/drawing/2014/main" id="{33662BC7-6097-3267-0A5E-4EA37604E1D0}"/>
              </a:ext>
            </a:extLst>
          </p:cNvPr>
          <p:cNvCxnSpPr>
            <a:cxnSpLocks/>
          </p:cNvCxnSpPr>
          <p:nvPr/>
        </p:nvCxnSpPr>
        <p:spPr>
          <a:xfrm>
            <a:off x="8265818" y="4070193"/>
            <a:ext cx="246686" cy="0"/>
          </a:xfrm>
          <a:prstGeom prst="line">
            <a:avLst/>
          </a:prstGeom>
          <a:ln w="5397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40E3E358-5DD5-2DAC-8185-F36052909608}"/>
              </a:ext>
            </a:extLst>
          </p:cNvPr>
          <p:cNvSpPr txBox="1"/>
          <p:nvPr/>
        </p:nvSpPr>
        <p:spPr>
          <a:xfrm>
            <a:off x="7884688" y="410403"/>
            <a:ext cx="522900"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B.</a:t>
            </a:r>
          </a:p>
        </p:txBody>
      </p:sp>
      <p:sp>
        <p:nvSpPr>
          <p:cNvPr id="33" name="TextBox 32">
            <a:extLst>
              <a:ext uri="{FF2B5EF4-FFF2-40B4-BE49-F238E27FC236}">
                <a16:creationId xmlns:a16="http://schemas.microsoft.com/office/drawing/2014/main" id="{7BD36EC0-20C8-1D17-DCFD-B9BE3F5EA06F}"/>
              </a:ext>
            </a:extLst>
          </p:cNvPr>
          <p:cNvSpPr txBox="1"/>
          <p:nvPr/>
        </p:nvSpPr>
        <p:spPr>
          <a:xfrm>
            <a:off x="0" y="301819"/>
            <a:ext cx="522900"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AB8A72B4-7BF1-5E0C-67F8-E663F172223F}"/>
              </a:ext>
            </a:extLst>
          </p:cNvPr>
          <p:cNvSpPr txBox="1"/>
          <p:nvPr/>
        </p:nvSpPr>
        <p:spPr>
          <a:xfrm>
            <a:off x="0" y="5242706"/>
            <a:ext cx="7686785" cy="1600438"/>
          </a:xfrm>
          <a:prstGeom prst="rect">
            <a:avLst/>
          </a:prstGeom>
          <a:noFill/>
        </p:spPr>
        <p:txBody>
          <a:bodyPr wrap="square">
            <a:spAutoFit/>
          </a:bodyPr>
          <a:lstStyle/>
          <a:p>
            <a:pPr marL="0" marR="0" indent="457200">
              <a:spcBef>
                <a:spcPts val="0"/>
              </a:spcBef>
              <a:spcAft>
                <a:spcPts val="0"/>
              </a:spcAft>
            </a:pPr>
            <a:r>
              <a:rPr lang="en-US" sz="1400" dirty="0">
                <a:effectLst/>
                <a:latin typeface="Arial" panose="020B0604020202020204" pitchFamily="34" charset="0"/>
                <a:ea typeface="Calibri" panose="020F0502020204030204" pitchFamily="34" charset="0"/>
                <a:cs typeface="Arial" panose="020B0604020202020204" pitchFamily="34" charset="0"/>
              </a:rPr>
              <a:t>Supplementary Figure 2: A. A drug screen of 106 known epigenetic compounds was conducted against two IDH1 mutant (252 and BT-142) and three IDH1 wildtype lines (357, 385, 412) at four drug concentrations (10nM, 100nM, 1uM, 10uM) for three days. Viable cell number was estimated by MTT. Average IDH1mut viability was compared to average IDH1WT viability and displayed as area under the curve (IDH1mut/IDH1WT).  B. A heatma</a:t>
            </a:r>
            <a:r>
              <a:rPr lang="en-US" sz="1400" dirty="0">
                <a:latin typeface="Arial" panose="020B0604020202020204" pitchFamily="34" charset="0"/>
                <a:ea typeface="Calibri" panose="020F0502020204030204" pitchFamily="34" charset="0"/>
                <a:cs typeface="Arial" panose="020B0604020202020204" pitchFamily="34" charset="0"/>
              </a:rPr>
              <a:t>p of the five cell lines and  associated MTT viabilities is shown. C. An example of the AUC calculation for the compound LBH is shown.</a:t>
            </a:r>
            <a:endParaRPr lang="en-US" sz="1400" dirty="0">
              <a:effectLst/>
              <a:latin typeface="Arial" panose="020B0604020202020204" pitchFamily="34" charset="0"/>
              <a:ea typeface="Calibri" panose="020F0502020204030204" pitchFamily="34" charset="0"/>
              <a:cs typeface="Arial" panose="020B0604020202020204" pitchFamily="34" charset="0"/>
            </a:endParaRPr>
          </a:p>
        </p:txBody>
      </p:sp>
      <p:grpSp>
        <p:nvGrpSpPr>
          <p:cNvPr id="5" name="Group 4">
            <a:extLst>
              <a:ext uri="{FF2B5EF4-FFF2-40B4-BE49-F238E27FC236}">
                <a16:creationId xmlns:a16="http://schemas.microsoft.com/office/drawing/2014/main" id="{EF771346-263C-D4D9-4C5D-B2F0BBCA82AE}"/>
              </a:ext>
            </a:extLst>
          </p:cNvPr>
          <p:cNvGrpSpPr/>
          <p:nvPr/>
        </p:nvGrpSpPr>
        <p:grpSpPr>
          <a:xfrm>
            <a:off x="8342023" y="4541723"/>
            <a:ext cx="3927942" cy="2301421"/>
            <a:chOff x="689311" y="3943765"/>
            <a:chExt cx="4810564" cy="2805031"/>
          </a:xfrm>
        </p:grpSpPr>
        <p:pic>
          <p:nvPicPr>
            <p:cNvPr id="13" name="Picture 12">
              <a:extLst>
                <a:ext uri="{FF2B5EF4-FFF2-40B4-BE49-F238E27FC236}">
                  <a16:creationId xmlns:a16="http://schemas.microsoft.com/office/drawing/2014/main" id="{E4093582-464E-EB60-BA15-A8EA7F540C50}"/>
                </a:ext>
              </a:extLst>
            </p:cNvPr>
            <p:cNvPicPr>
              <a:picLocks noChangeAspect="1"/>
            </p:cNvPicPr>
            <p:nvPr/>
          </p:nvPicPr>
          <p:blipFill>
            <a:blip r:embed="rId4"/>
            <a:stretch>
              <a:fillRect/>
            </a:stretch>
          </p:blipFill>
          <p:spPr>
            <a:xfrm>
              <a:off x="691011" y="3943765"/>
              <a:ext cx="1417204" cy="1295363"/>
            </a:xfrm>
            <a:prstGeom prst="rect">
              <a:avLst/>
            </a:prstGeom>
          </p:spPr>
        </p:pic>
        <p:pic>
          <p:nvPicPr>
            <p:cNvPr id="15" name="Picture 14">
              <a:extLst>
                <a:ext uri="{FF2B5EF4-FFF2-40B4-BE49-F238E27FC236}">
                  <a16:creationId xmlns:a16="http://schemas.microsoft.com/office/drawing/2014/main" id="{532756F0-BF01-293A-293F-9FBE8B44D4FB}"/>
                </a:ext>
              </a:extLst>
            </p:cNvPr>
            <p:cNvPicPr>
              <a:picLocks noChangeAspect="1"/>
            </p:cNvPicPr>
            <p:nvPr/>
          </p:nvPicPr>
          <p:blipFill>
            <a:blip r:embed="rId5"/>
            <a:stretch>
              <a:fillRect/>
            </a:stretch>
          </p:blipFill>
          <p:spPr>
            <a:xfrm>
              <a:off x="689311" y="5375465"/>
              <a:ext cx="1451220" cy="1326454"/>
            </a:xfrm>
            <a:prstGeom prst="rect">
              <a:avLst/>
            </a:prstGeom>
          </p:spPr>
        </p:pic>
        <p:pic>
          <p:nvPicPr>
            <p:cNvPr id="18" name="Picture 17">
              <a:extLst>
                <a:ext uri="{FF2B5EF4-FFF2-40B4-BE49-F238E27FC236}">
                  <a16:creationId xmlns:a16="http://schemas.microsoft.com/office/drawing/2014/main" id="{DBBADD24-40D2-E1BD-1F13-AC0E0C271530}"/>
                </a:ext>
              </a:extLst>
            </p:cNvPr>
            <p:cNvPicPr>
              <a:picLocks noChangeAspect="1"/>
            </p:cNvPicPr>
            <p:nvPr/>
          </p:nvPicPr>
          <p:blipFill>
            <a:blip r:embed="rId6"/>
            <a:stretch>
              <a:fillRect/>
            </a:stretch>
          </p:blipFill>
          <p:spPr>
            <a:xfrm>
              <a:off x="2021084" y="5422341"/>
              <a:ext cx="1451220" cy="1326455"/>
            </a:xfrm>
            <a:prstGeom prst="rect">
              <a:avLst/>
            </a:prstGeom>
          </p:spPr>
        </p:pic>
        <p:pic>
          <p:nvPicPr>
            <p:cNvPr id="21" name="Picture 20">
              <a:extLst>
                <a:ext uri="{FF2B5EF4-FFF2-40B4-BE49-F238E27FC236}">
                  <a16:creationId xmlns:a16="http://schemas.microsoft.com/office/drawing/2014/main" id="{71339619-9AD0-C432-E2F5-2560BE9FD674}"/>
                </a:ext>
              </a:extLst>
            </p:cNvPr>
            <p:cNvPicPr>
              <a:picLocks noChangeAspect="1"/>
            </p:cNvPicPr>
            <p:nvPr/>
          </p:nvPicPr>
          <p:blipFill>
            <a:blip r:embed="rId7"/>
            <a:stretch>
              <a:fillRect/>
            </a:stretch>
          </p:blipFill>
          <p:spPr>
            <a:xfrm>
              <a:off x="3352855" y="5402360"/>
              <a:ext cx="1451220" cy="1326454"/>
            </a:xfrm>
            <a:prstGeom prst="rect">
              <a:avLst/>
            </a:prstGeom>
          </p:spPr>
        </p:pic>
        <p:pic>
          <p:nvPicPr>
            <p:cNvPr id="22" name="Picture 21">
              <a:extLst>
                <a:ext uri="{FF2B5EF4-FFF2-40B4-BE49-F238E27FC236}">
                  <a16:creationId xmlns:a16="http://schemas.microsoft.com/office/drawing/2014/main" id="{7A245DEA-5881-DA53-6098-CD3C6F1E19A4}"/>
                </a:ext>
              </a:extLst>
            </p:cNvPr>
            <p:cNvPicPr>
              <a:picLocks noChangeAspect="1"/>
            </p:cNvPicPr>
            <p:nvPr/>
          </p:nvPicPr>
          <p:blipFill>
            <a:blip r:embed="rId8"/>
            <a:stretch>
              <a:fillRect/>
            </a:stretch>
          </p:blipFill>
          <p:spPr>
            <a:xfrm>
              <a:off x="1967000" y="3950675"/>
              <a:ext cx="1451220" cy="1326454"/>
            </a:xfrm>
            <a:prstGeom prst="rect">
              <a:avLst/>
            </a:prstGeom>
          </p:spPr>
        </p:pic>
        <p:sp>
          <p:nvSpPr>
            <p:cNvPr id="23" name="Freeform 22">
              <a:extLst>
                <a:ext uri="{FF2B5EF4-FFF2-40B4-BE49-F238E27FC236}">
                  <a16:creationId xmlns:a16="http://schemas.microsoft.com/office/drawing/2014/main" id="{6D030D23-B48E-E213-59FF-9E30332BC686}"/>
                </a:ext>
              </a:extLst>
            </p:cNvPr>
            <p:cNvSpPr/>
            <p:nvPr/>
          </p:nvSpPr>
          <p:spPr>
            <a:xfrm>
              <a:off x="2486825" y="5996835"/>
              <a:ext cx="698091" cy="612742"/>
            </a:xfrm>
            <a:custGeom>
              <a:avLst/>
              <a:gdLst>
                <a:gd name="connsiteX0" fmla="*/ 19361 w 698091"/>
                <a:gd name="connsiteY0" fmla="*/ 593889 h 612742"/>
                <a:gd name="connsiteX1" fmla="*/ 19361 w 698091"/>
                <a:gd name="connsiteY1" fmla="*/ 593889 h 612742"/>
                <a:gd name="connsiteX2" fmla="*/ 9934 w 698091"/>
                <a:gd name="connsiteY2" fmla="*/ 395926 h 612742"/>
                <a:gd name="connsiteX3" fmla="*/ 19361 w 698091"/>
                <a:gd name="connsiteY3" fmla="*/ 348792 h 612742"/>
                <a:gd name="connsiteX4" fmla="*/ 245604 w 698091"/>
                <a:gd name="connsiteY4" fmla="*/ 424206 h 612742"/>
                <a:gd name="connsiteX5" fmla="*/ 443567 w 698091"/>
                <a:gd name="connsiteY5" fmla="*/ 0 h 612742"/>
                <a:gd name="connsiteX6" fmla="*/ 688664 w 698091"/>
                <a:gd name="connsiteY6" fmla="*/ 37707 h 612742"/>
                <a:gd name="connsiteX7" fmla="*/ 698091 w 698091"/>
                <a:gd name="connsiteY7" fmla="*/ 612742 h 612742"/>
                <a:gd name="connsiteX8" fmla="*/ 19361 w 698091"/>
                <a:gd name="connsiteY8" fmla="*/ 593889 h 6127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698091" h="612742">
                  <a:moveTo>
                    <a:pt x="19361" y="593889"/>
                  </a:moveTo>
                  <a:lnTo>
                    <a:pt x="19361" y="593889"/>
                  </a:lnTo>
                  <a:cubicBezTo>
                    <a:pt x="16219" y="527901"/>
                    <a:pt x="15202" y="461778"/>
                    <a:pt x="9934" y="395926"/>
                  </a:cubicBezTo>
                  <a:cubicBezTo>
                    <a:pt x="6081" y="347763"/>
                    <a:pt x="-15028" y="365987"/>
                    <a:pt x="19361" y="348792"/>
                  </a:cubicBezTo>
                  <a:lnTo>
                    <a:pt x="245604" y="424206"/>
                  </a:lnTo>
                  <a:lnTo>
                    <a:pt x="443567" y="0"/>
                  </a:lnTo>
                  <a:lnTo>
                    <a:pt x="688664" y="37707"/>
                  </a:lnTo>
                  <a:lnTo>
                    <a:pt x="698091" y="612742"/>
                  </a:lnTo>
                  <a:lnTo>
                    <a:pt x="19361" y="593889"/>
                  </a:lnTo>
                  <a:close/>
                </a:path>
              </a:pathLst>
            </a:cu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4" name="Freeform 23">
              <a:extLst>
                <a:ext uri="{FF2B5EF4-FFF2-40B4-BE49-F238E27FC236}">
                  <a16:creationId xmlns:a16="http://schemas.microsoft.com/office/drawing/2014/main" id="{7082713C-7CAD-A9E8-BD50-FA09ACE61BF9}"/>
                </a:ext>
              </a:extLst>
            </p:cNvPr>
            <p:cNvSpPr/>
            <p:nvPr/>
          </p:nvSpPr>
          <p:spPr>
            <a:xfrm>
              <a:off x="3835365" y="5949701"/>
              <a:ext cx="659876" cy="641023"/>
            </a:xfrm>
            <a:custGeom>
              <a:avLst/>
              <a:gdLst>
                <a:gd name="connsiteX0" fmla="*/ 9427 w 659876"/>
                <a:gd name="connsiteY0" fmla="*/ 631596 h 641023"/>
                <a:gd name="connsiteX1" fmla="*/ 9427 w 659876"/>
                <a:gd name="connsiteY1" fmla="*/ 631596 h 641023"/>
                <a:gd name="connsiteX2" fmla="*/ 0 w 659876"/>
                <a:gd name="connsiteY2" fmla="*/ 273377 h 641023"/>
                <a:gd name="connsiteX3" fmla="*/ 9427 w 659876"/>
                <a:gd name="connsiteY3" fmla="*/ 103695 h 641023"/>
                <a:gd name="connsiteX4" fmla="*/ 235670 w 659876"/>
                <a:gd name="connsiteY4" fmla="*/ 131975 h 641023"/>
                <a:gd name="connsiteX5" fmla="*/ 461913 w 659876"/>
                <a:gd name="connsiteY5" fmla="*/ 0 h 641023"/>
                <a:gd name="connsiteX6" fmla="*/ 659876 w 659876"/>
                <a:gd name="connsiteY6" fmla="*/ 9427 h 641023"/>
                <a:gd name="connsiteX7" fmla="*/ 659876 w 659876"/>
                <a:gd name="connsiteY7" fmla="*/ 641023 h 641023"/>
                <a:gd name="connsiteX8" fmla="*/ 9427 w 659876"/>
                <a:gd name="connsiteY8" fmla="*/ 631596 h 64102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659876" h="641023">
                  <a:moveTo>
                    <a:pt x="9427" y="631596"/>
                  </a:moveTo>
                  <a:lnTo>
                    <a:pt x="9427" y="631596"/>
                  </a:lnTo>
                  <a:cubicBezTo>
                    <a:pt x="6285" y="512190"/>
                    <a:pt x="0" y="392825"/>
                    <a:pt x="0" y="273377"/>
                  </a:cubicBezTo>
                  <a:cubicBezTo>
                    <a:pt x="0" y="216729"/>
                    <a:pt x="9427" y="160343"/>
                    <a:pt x="9427" y="103695"/>
                  </a:cubicBezTo>
                  <a:lnTo>
                    <a:pt x="235670" y="131975"/>
                  </a:lnTo>
                  <a:lnTo>
                    <a:pt x="461913" y="0"/>
                  </a:lnTo>
                  <a:lnTo>
                    <a:pt x="659876" y="9427"/>
                  </a:lnTo>
                  <a:lnTo>
                    <a:pt x="659876" y="641023"/>
                  </a:lnTo>
                  <a:lnTo>
                    <a:pt x="9427" y="631596"/>
                  </a:lnTo>
                  <a:close/>
                </a:path>
              </a:pathLst>
            </a:cu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5" name="Freeform 24">
              <a:extLst>
                <a:ext uri="{FF2B5EF4-FFF2-40B4-BE49-F238E27FC236}">
                  <a16:creationId xmlns:a16="http://schemas.microsoft.com/office/drawing/2014/main" id="{A33D297B-682F-14E1-9141-C816150722F5}"/>
                </a:ext>
              </a:extLst>
            </p:cNvPr>
            <p:cNvSpPr/>
            <p:nvPr/>
          </p:nvSpPr>
          <p:spPr>
            <a:xfrm>
              <a:off x="1177006" y="5930847"/>
              <a:ext cx="650450" cy="631596"/>
            </a:xfrm>
            <a:custGeom>
              <a:avLst/>
              <a:gdLst>
                <a:gd name="connsiteX0" fmla="*/ 0 w 650450"/>
                <a:gd name="connsiteY0" fmla="*/ 622169 h 631596"/>
                <a:gd name="connsiteX1" fmla="*/ 0 w 650450"/>
                <a:gd name="connsiteY1" fmla="*/ 311085 h 631596"/>
                <a:gd name="connsiteX2" fmla="*/ 226244 w 650450"/>
                <a:gd name="connsiteY2" fmla="*/ 273378 h 631596"/>
                <a:gd name="connsiteX3" fmla="*/ 433633 w 650450"/>
                <a:gd name="connsiteY3" fmla="*/ 9427 h 631596"/>
                <a:gd name="connsiteX4" fmla="*/ 650450 w 650450"/>
                <a:gd name="connsiteY4" fmla="*/ 0 h 631596"/>
                <a:gd name="connsiteX5" fmla="*/ 650450 w 650450"/>
                <a:gd name="connsiteY5" fmla="*/ 631596 h 631596"/>
                <a:gd name="connsiteX6" fmla="*/ 0 w 650450"/>
                <a:gd name="connsiteY6" fmla="*/ 622169 h 6315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50450" h="631596">
                  <a:moveTo>
                    <a:pt x="0" y="622169"/>
                  </a:moveTo>
                  <a:lnTo>
                    <a:pt x="0" y="311085"/>
                  </a:lnTo>
                  <a:lnTo>
                    <a:pt x="226244" y="273378"/>
                  </a:lnTo>
                  <a:lnTo>
                    <a:pt x="433633" y="9427"/>
                  </a:lnTo>
                  <a:lnTo>
                    <a:pt x="650450" y="0"/>
                  </a:lnTo>
                  <a:lnTo>
                    <a:pt x="650450" y="631596"/>
                  </a:lnTo>
                  <a:lnTo>
                    <a:pt x="0" y="622169"/>
                  </a:lnTo>
                  <a:close/>
                </a:path>
              </a:pathLst>
            </a:cu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6" name="Freeform 25">
              <a:extLst>
                <a:ext uri="{FF2B5EF4-FFF2-40B4-BE49-F238E27FC236}">
                  <a16:creationId xmlns:a16="http://schemas.microsoft.com/office/drawing/2014/main" id="{27C7E0D7-53C1-44E3-E11E-2D9F124AB522}"/>
                </a:ext>
              </a:extLst>
            </p:cNvPr>
            <p:cNvSpPr/>
            <p:nvPr/>
          </p:nvSpPr>
          <p:spPr>
            <a:xfrm>
              <a:off x="2450776" y="4616288"/>
              <a:ext cx="659877" cy="518474"/>
            </a:xfrm>
            <a:custGeom>
              <a:avLst/>
              <a:gdLst>
                <a:gd name="connsiteX0" fmla="*/ 0 w 659877"/>
                <a:gd name="connsiteY0" fmla="*/ 509048 h 518474"/>
                <a:gd name="connsiteX1" fmla="*/ 0 w 659877"/>
                <a:gd name="connsiteY1" fmla="*/ 405353 h 518474"/>
                <a:gd name="connsiteX2" fmla="*/ 226244 w 659877"/>
                <a:gd name="connsiteY2" fmla="*/ 414780 h 518474"/>
                <a:gd name="connsiteX3" fmla="*/ 433633 w 659877"/>
                <a:gd name="connsiteY3" fmla="*/ 292231 h 518474"/>
                <a:gd name="connsiteX4" fmla="*/ 659877 w 659877"/>
                <a:gd name="connsiteY4" fmla="*/ 0 h 518474"/>
                <a:gd name="connsiteX5" fmla="*/ 659877 w 659877"/>
                <a:gd name="connsiteY5" fmla="*/ 518474 h 518474"/>
                <a:gd name="connsiteX6" fmla="*/ 0 w 659877"/>
                <a:gd name="connsiteY6" fmla="*/ 509048 h 51847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59877" h="518474">
                  <a:moveTo>
                    <a:pt x="0" y="509048"/>
                  </a:moveTo>
                  <a:lnTo>
                    <a:pt x="0" y="405353"/>
                  </a:lnTo>
                  <a:lnTo>
                    <a:pt x="226244" y="414780"/>
                  </a:lnTo>
                  <a:lnTo>
                    <a:pt x="433633" y="292231"/>
                  </a:lnTo>
                  <a:lnTo>
                    <a:pt x="659877" y="0"/>
                  </a:lnTo>
                  <a:lnTo>
                    <a:pt x="659877" y="518474"/>
                  </a:lnTo>
                  <a:lnTo>
                    <a:pt x="0" y="509048"/>
                  </a:lnTo>
                  <a:close/>
                </a:path>
              </a:pathLst>
            </a:cu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7" name="Freeform 26">
              <a:extLst>
                <a:ext uri="{FF2B5EF4-FFF2-40B4-BE49-F238E27FC236}">
                  <a16:creationId xmlns:a16="http://schemas.microsoft.com/office/drawing/2014/main" id="{CDA2140B-4C78-172A-8453-2F6474EA5F96}"/>
                </a:ext>
              </a:extLst>
            </p:cNvPr>
            <p:cNvSpPr/>
            <p:nvPr/>
          </p:nvSpPr>
          <p:spPr>
            <a:xfrm>
              <a:off x="1178158" y="4399472"/>
              <a:ext cx="622169" cy="707010"/>
            </a:xfrm>
            <a:custGeom>
              <a:avLst/>
              <a:gdLst>
                <a:gd name="connsiteX0" fmla="*/ 0 w 622169"/>
                <a:gd name="connsiteY0" fmla="*/ 697583 h 707010"/>
                <a:gd name="connsiteX1" fmla="*/ 0 w 622169"/>
                <a:gd name="connsiteY1" fmla="*/ 612742 h 707010"/>
                <a:gd name="connsiteX2" fmla="*/ 207390 w 622169"/>
                <a:gd name="connsiteY2" fmla="*/ 622169 h 707010"/>
                <a:gd name="connsiteX3" fmla="*/ 424206 w 622169"/>
                <a:gd name="connsiteY3" fmla="*/ 565608 h 707010"/>
                <a:gd name="connsiteX4" fmla="*/ 622169 w 622169"/>
                <a:gd name="connsiteY4" fmla="*/ 0 h 707010"/>
                <a:gd name="connsiteX5" fmla="*/ 622169 w 622169"/>
                <a:gd name="connsiteY5" fmla="*/ 707010 h 707010"/>
                <a:gd name="connsiteX6" fmla="*/ 0 w 622169"/>
                <a:gd name="connsiteY6" fmla="*/ 697583 h 70701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22169" h="707010">
                  <a:moveTo>
                    <a:pt x="0" y="697583"/>
                  </a:moveTo>
                  <a:lnTo>
                    <a:pt x="0" y="612742"/>
                  </a:lnTo>
                  <a:lnTo>
                    <a:pt x="207390" y="622169"/>
                  </a:lnTo>
                  <a:lnTo>
                    <a:pt x="424206" y="565608"/>
                  </a:lnTo>
                  <a:lnTo>
                    <a:pt x="622169" y="0"/>
                  </a:lnTo>
                  <a:lnTo>
                    <a:pt x="622169" y="707010"/>
                  </a:lnTo>
                  <a:lnTo>
                    <a:pt x="0" y="697583"/>
                  </a:lnTo>
                  <a:close/>
                </a:path>
              </a:pathLst>
            </a:cu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nvGrpSpPr>
            <p:cNvPr id="28" name="Group 27">
              <a:extLst>
                <a:ext uri="{FF2B5EF4-FFF2-40B4-BE49-F238E27FC236}">
                  <a16:creationId xmlns:a16="http://schemas.microsoft.com/office/drawing/2014/main" id="{4FC21972-8CCF-542A-BD22-BB461C8508FD}"/>
                </a:ext>
              </a:extLst>
            </p:cNvPr>
            <p:cNvGrpSpPr/>
            <p:nvPr/>
          </p:nvGrpSpPr>
          <p:grpSpPr>
            <a:xfrm>
              <a:off x="3964969" y="4318654"/>
              <a:ext cx="1534906" cy="747161"/>
              <a:chOff x="1408089" y="4798985"/>
              <a:chExt cx="1740669" cy="909193"/>
            </a:xfrm>
          </p:grpSpPr>
          <p:sp>
            <p:nvSpPr>
              <p:cNvPr id="29" name="TextBox 28">
                <a:extLst>
                  <a:ext uri="{FF2B5EF4-FFF2-40B4-BE49-F238E27FC236}">
                    <a16:creationId xmlns:a16="http://schemas.microsoft.com/office/drawing/2014/main" id="{62A217E4-4DB3-2D49-1287-81A48CDDBDBC}"/>
                  </a:ext>
                </a:extLst>
              </p:cNvPr>
              <p:cNvSpPr txBox="1"/>
              <p:nvPr/>
            </p:nvSpPr>
            <p:spPr>
              <a:xfrm>
                <a:off x="1784583" y="4809320"/>
                <a:ext cx="1347406" cy="502125"/>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IDH1WT</a:t>
                </a:r>
              </a:p>
            </p:txBody>
          </p:sp>
          <p:sp>
            <p:nvSpPr>
              <p:cNvPr id="30" name="TextBox 29">
                <a:extLst>
                  <a:ext uri="{FF2B5EF4-FFF2-40B4-BE49-F238E27FC236}">
                    <a16:creationId xmlns:a16="http://schemas.microsoft.com/office/drawing/2014/main" id="{00B584A2-ACC8-419C-5442-FB5CC66B88E1}"/>
                  </a:ext>
                </a:extLst>
              </p:cNvPr>
              <p:cNvSpPr txBox="1"/>
              <p:nvPr/>
            </p:nvSpPr>
            <p:spPr>
              <a:xfrm>
                <a:off x="1767955" y="5206053"/>
                <a:ext cx="1380803" cy="502125"/>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IDH1mut</a:t>
                </a:r>
              </a:p>
            </p:txBody>
          </p:sp>
          <p:sp>
            <p:nvSpPr>
              <p:cNvPr id="31" name="Rectangle 30">
                <a:extLst>
                  <a:ext uri="{FF2B5EF4-FFF2-40B4-BE49-F238E27FC236}">
                    <a16:creationId xmlns:a16="http://schemas.microsoft.com/office/drawing/2014/main" id="{32A19E9E-A3A3-E360-BCE4-88B030A310F7}"/>
                  </a:ext>
                </a:extLst>
              </p:cNvPr>
              <p:cNvSpPr/>
              <p:nvPr/>
            </p:nvSpPr>
            <p:spPr>
              <a:xfrm>
                <a:off x="1408089" y="4798985"/>
                <a:ext cx="376494" cy="328242"/>
              </a:xfrm>
              <a:prstGeom prst="rect">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4" name="Rectangle 33">
                <a:extLst>
                  <a:ext uri="{FF2B5EF4-FFF2-40B4-BE49-F238E27FC236}">
                    <a16:creationId xmlns:a16="http://schemas.microsoft.com/office/drawing/2014/main" id="{E7EBA988-EFA4-1000-0A91-CD142061FEBD}"/>
                  </a:ext>
                </a:extLst>
              </p:cNvPr>
              <p:cNvSpPr/>
              <p:nvPr/>
            </p:nvSpPr>
            <p:spPr>
              <a:xfrm flipV="1">
                <a:off x="1410257" y="5199488"/>
                <a:ext cx="353189" cy="320993"/>
              </a:xfrm>
              <a:prstGeom prst="rect">
                <a:avLst/>
              </a:prstGeom>
              <a:solidFill>
                <a:srgbClr val="FF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41340442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32</Words>
  <Application>Microsoft Macintosh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rett, Matthew (garretm4)</dc:creator>
  <cp:lastModifiedBy>Garrett, Matthew (garretm4)</cp:lastModifiedBy>
  <cp:revision>1</cp:revision>
  <dcterms:created xsi:type="dcterms:W3CDTF">2023-01-19T01:45:43Z</dcterms:created>
  <dcterms:modified xsi:type="dcterms:W3CDTF">2023-01-19T01:46:05Z</dcterms:modified>
</cp:coreProperties>
</file>